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23" r:id="rId2"/>
  </p:sldIdLst>
  <p:sldSz cx="7200900" cy="9144000"/>
  <p:notesSz cx="6797675" cy="9928225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10" userDrawn="1">
          <p15:clr>
            <a:srgbClr val="A4A3A4"/>
          </p15:clr>
        </p15:guide>
        <p15:guide id="2" pos="72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FFCC00"/>
    <a:srgbClr val="FF9900"/>
    <a:srgbClr val="FF6703"/>
    <a:srgbClr val="5B9BD5"/>
    <a:srgbClr val="8ACCFF"/>
    <a:srgbClr val="B5E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4741" autoAdjust="0"/>
    <p:restoredTop sz="99482" autoAdjust="0"/>
  </p:normalViewPr>
  <p:slideViewPr>
    <p:cSldViewPr snapToGrid="0">
      <p:cViewPr>
        <p:scale>
          <a:sx n="125" d="100"/>
          <a:sy n="125" d="100"/>
        </p:scale>
        <p:origin x="1424" y="528"/>
      </p:cViewPr>
      <p:guideLst>
        <p:guide orient="horz" pos="1610"/>
        <p:guide pos="726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90012" cy="90012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ewme\Documents\Ewa\manuscripts%20current\dFC2-aspen\data\DFC2%20-saccharification-recalculation%202015-10-04.xlsx" TargetMode="External"/><Relationship Id="rId2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pretretment liquid_Cal_JMP '!$P$21</c:f>
              <c:strCache>
                <c:ptCount val="1"/>
                <c:pt idx="0">
                  <c:v>WT </c:v>
                </c:pt>
              </c:strCache>
            </c:strRef>
          </c:tx>
          <c:spPr>
            <a:solidFill>
              <a:srgbClr val="5B9BD5"/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pretretment liquid_Cal_JMP '!$Q$27:$U$27</c:f>
                <c:numCache>
                  <c:formatCode>General</c:formatCode>
                  <c:ptCount val="5"/>
                  <c:pt idx="0">
                    <c:v>0.00233747</c:v>
                  </c:pt>
                  <c:pt idx="1">
                    <c:v>0.00249592</c:v>
                  </c:pt>
                  <c:pt idx="2">
                    <c:v>0.00085916</c:v>
                  </c:pt>
                  <c:pt idx="3">
                    <c:v>0.00166078</c:v>
                  </c:pt>
                  <c:pt idx="4">
                    <c:v>0.00040574</c:v>
                  </c:pt>
                </c:numCache>
              </c:numRef>
            </c:plus>
            <c:minus>
              <c:numRef>
                <c:f>'pretretment liquid_Cal_JMP '!$Q$27:$U$27</c:f>
                <c:numCache>
                  <c:formatCode>General</c:formatCode>
                  <c:ptCount val="5"/>
                  <c:pt idx="0">
                    <c:v>0.00233747</c:v>
                  </c:pt>
                  <c:pt idx="1">
                    <c:v>0.00249592</c:v>
                  </c:pt>
                  <c:pt idx="2">
                    <c:v>0.00085916</c:v>
                  </c:pt>
                  <c:pt idx="3">
                    <c:v>0.00166078</c:v>
                  </c:pt>
                  <c:pt idx="4">
                    <c:v>0.00040574</c:v>
                  </c:pt>
                </c:numCache>
              </c:numRef>
            </c:minus>
          </c:errBars>
          <c:cat>
            <c:strRef>
              <c:f>'pretretment liquid_Cal_JMP '!$Q$1:$U$1</c:f>
              <c:strCache>
                <c:ptCount val="5"/>
                <c:pt idx="0">
                  <c:v> Glucan </c:v>
                </c:pt>
                <c:pt idx="1">
                  <c:v>Xylan </c:v>
                </c:pt>
                <c:pt idx="2">
                  <c:v>Mannan</c:v>
                </c:pt>
                <c:pt idx="3">
                  <c:v>Galactan </c:v>
                </c:pt>
                <c:pt idx="4">
                  <c:v>Arabinan</c:v>
                </c:pt>
              </c:strCache>
            </c:strRef>
          </c:cat>
          <c:val>
            <c:numRef>
              <c:f>'pretretment liquid_Cal_JMP '!$Q$21:$U$21</c:f>
              <c:numCache>
                <c:formatCode>General</c:formatCode>
                <c:ptCount val="5"/>
                <c:pt idx="0">
                  <c:v>0.06684252</c:v>
                </c:pt>
                <c:pt idx="1">
                  <c:v>0.16179342</c:v>
                </c:pt>
                <c:pt idx="2">
                  <c:v>0.02175034</c:v>
                </c:pt>
                <c:pt idx="3">
                  <c:v>0.01275191</c:v>
                </c:pt>
                <c:pt idx="4">
                  <c:v>0.01090089</c:v>
                </c:pt>
              </c:numCache>
            </c:numRef>
          </c:val>
        </c:ser>
        <c:ser>
          <c:idx val="1"/>
          <c:order val="1"/>
          <c:tx>
            <c:strRef>
              <c:f>'pretretment liquid_Cal_JMP '!$P$22</c:f>
              <c:strCache>
                <c:ptCount val="1"/>
                <c:pt idx="0">
                  <c:v>8</c:v>
                </c:pt>
              </c:strCache>
            </c:strRef>
          </c:tx>
          <c:spPr>
            <a:solidFill>
              <a:srgbClr val="FF6703"/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pretretment liquid_Cal_JMP '!$Q$28:$U$28</c:f>
                <c:numCache>
                  <c:formatCode>General</c:formatCode>
                  <c:ptCount val="5"/>
                  <c:pt idx="0">
                    <c:v>0.00233747</c:v>
                  </c:pt>
                  <c:pt idx="1">
                    <c:v>0.00249592</c:v>
                  </c:pt>
                  <c:pt idx="2">
                    <c:v>0.00085916</c:v>
                  </c:pt>
                  <c:pt idx="3">
                    <c:v>0.00166078</c:v>
                  </c:pt>
                  <c:pt idx="4">
                    <c:v>0.00040574</c:v>
                  </c:pt>
                </c:numCache>
              </c:numRef>
            </c:plus>
            <c:minus>
              <c:numRef>
                <c:f>'pretretment liquid_Cal_JMP '!$Q$28:$U$28</c:f>
                <c:numCache>
                  <c:formatCode>General</c:formatCode>
                  <c:ptCount val="5"/>
                  <c:pt idx="0">
                    <c:v>0.00233747</c:v>
                  </c:pt>
                  <c:pt idx="1">
                    <c:v>0.00249592</c:v>
                  </c:pt>
                  <c:pt idx="2">
                    <c:v>0.00085916</c:v>
                  </c:pt>
                  <c:pt idx="3">
                    <c:v>0.00166078</c:v>
                  </c:pt>
                  <c:pt idx="4">
                    <c:v>0.00040574</c:v>
                  </c:pt>
                </c:numCache>
              </c:numRef>
            </c:minus>
          </c:errBars>
          <c:cat>
            <c:strRef>
              <c:f>'pretretment liquid_Cal_JMP '!$Q$1:$U$1</c:f>
              <c:strCache>
                <c:ptCount val="5"/>
                <c:pt idx="0">
                  <c:v> Glucan </c:v>
                </c:pt>
                <c:pt idx="1">
                  <c:v>Xylan </c:v>
                </c:pt>
                <c:pt idx="2">
                  <c:v>Mannan</c:v>
                </c:pt>
                <c:pt idx="3">
                  <c:v>Galactan </c:v>
                </c:pt>
                <c:pt idx="4">
                  <c:v>Arabinan</c:v>
                </c:pt>
              </c:strCache>
            </c:strRef>
          </c:cat>
          <c:val>
            <c:numRef>
              <c:f>'pretretment liquid_Cal_JMP '!$Q$22:$U$22</c:f>
              <c:numCache>
                <c:formatCode>General</c:formatCode>
                <c:ptCount val="5"/>
                <c:pt idx="0">
                  <c:v>0.07968763</c:v>
                </c:pt>
                <c:pt idx="1">
                  <c:v>0.16844658</c:v>
                </c:pt>
                <c:pt idx="2">
                  <c:v>0.02471229</c:v>
                </c:pt>
                <c:pt idx="3">
                  <c:v>0.0151471</c:v>
                </c:pt>
                <c:pt idx="4">
                  <c:v>0.00862091</c:v>
                </c:pt>
              </c:numCache>
            </c:numRef>
          </c:val>
        </c:ser>
        <c:ser>
          <c:idx val="2"/>
          <c:order val="2"/>
          <c:tx>
            <c:strRef>
              <c:f>'pretretment liquid_Cal_JMP '!$P$23</c:f>
              <c:strCache>
                <c:ptCount val="1"/>
                <c:pt idx="0">
                  <c:v>4</c:v>
                </c:pt>
              </c:strCache>
            </c:strRef>
          </c:tx>
          <c:spPr>
            <a:solidFill>
              <a:srgbClr val="FF9900"/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pretretment liquid_Cal_JMP '!$Q$29:$U$29</c:f>
                <c:numCache>
                  <c:formatCode>General</c:formatCode>
                  <c:ptCount val="5"/>
                  <c:pt idx="0">
                    <c:v>0.00233747</c:v>
                  </c:pt>
                  <c:pt idx="1">
                    <c:v>0.00249592</c:v>
                  </c:pt>
                  <c:pt idx="2">
                    <c:v>0.00085916</c:v>
                  </c:pt>
                  <c:pt idx="3">
                    <c:v>0.00166078</c:v>
                  </c:pt>
                  <c:pt idx="4">
                    <c:v>0.00040574</c:v>
                  </c:pt>
                </c:numCache>
              </c:numRef>
            </c:plus>
            <c:minus>
              <c:numRef>
                <c:f>'pretretment liquid_Cal_JMP '!$Q$29:$U$29</c:f>
                <c:numCache>
                  <c:formatCode>General</c:formatCode>
                  <c:ptCount val="5"/>
                  <c:pt idx="0">
                    <c:v>0.00233747</c:v>
                  </c:pt>
                  <c:pt idx="1">
                    <c:v>0.00249592</c:v>
                  </c:pt>
                  <c:pt idx="2">
                    <c:v>0.00085916</c:v>
                  </c:pt>
                  <c:pt idx="3">
                    <c:v>0.00166078</c:v>
                  </c:pt>
                  <c:pt idx="4">
                    <c:v>0.00040574</c:v>
                  </c:pt>
                </c:numCache>
              </c:numRef>
            </c:minus>
          </c:errBars>
          <c:cat>
            <c:strRef>
              <c:f>'pretretment liquid_Cal_JMP '!$Q$1:$U$1</c:f>
              <c:strCache>
                <c:ptCount val="5"/>
                <c:pt idx="0">
                  <c:v> Glucan </c:v>
                </c:pt>
                <c:pt idx="1">
                  <c:v>Xylan </c:v>
                </c:pt>
                <c:pt idx="2">
                  <c:v>Mannan</c:v>
                </c:pt>
                <c:pt idx="3">
                  <c:v>Galactan </c:v>
                </c:pt>
                <c:pt idx="4">
                  <c:v>Arabinan</c:v>
                </c:pt>
              </c:strCache>
            </c:strRef>
          </c:cat>
          <c:val>
            <c:numRef>
              <c:f>'pretretment liquid_Cal_JMP '!$Q$23:$U$23</c:f>
              <c:numCache>
                <c:formatCode>General</c:formatCode>
                <c:ptCount val="5"/>
                <c:pt idx="0">
                  <c:v>0.07157006</c:v>
                </c:pt>
                <c:pt idx="1">
                  <c:v>0.15557247</c:v>
                </c:pt>
                <c:pt idx="2">
                  <c:v>0.01996337</c:v>
                </c:pt>
                <c:pt idx="3">
                  <c:v>0.0166215</c:v>
                </c:pt>
                <c:pt idx="4">
                  <c:v>0.00854504</c:v>
                </c:pt>
              </c:numCache>
            </c:numRef>
          </c:val>
        </c:ser>
        <c:ser>
          <c:idx val="3"/>
          <c:order val="3"/>
          <c:tx>
            <c:strRef>
              <c:f>'pretretment liquid_Cal_JMP '!$P$24</c:f>
              <c:strCache>
                <c:ptCount val="1"/>
                <c:pt idx="0">
                  <c:v>17</c:v>
                </c:pt>
              </c:strCache>
            </c:strRef>
          </c:tx>
          <c:spPr>
            <a:solidFill>
              <a:srgbClr val="FFCC00"/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pretretment liquid_Cal_JMP '!$Q$30:$U$30</c:f>
                <c:numCache>
                  <c:formatCode>General</c:formatCode>
                  <c:ptCount val="5"/>
                  <c:pt idx="0">
                    <c:v>0.00233747</c:v>
                  </c:pt>
                  <c:pt idx="1">
                    <c:v>0.00249592</c:v>
                  </c:pt>
                  <c:pt idx="2">
                    <c:v>0.00085916</c:v>
                  </c:pt>
                  <c:pt idx="3">
                    <c:v>0.00166078</c:v>
                  </c:pt>
                  <c:pt idx="4">
                    <c:v>0.00040574</c:v>
                  </c:pt>
                </c:numCache>
              </c:numRef>
            </c:plus>
            <c:minus>
              <c:numRef>
                <c:f>'pretretment liquid_Cal_JMP '!$Q$30:$U$30</c:f>
                <c:numCache>
                  <c:formatCode>General</c:formatCode>
                  <c:ptCount val="5"/>
                  <c:pt idx="0">
                    <c:v>0.00233747</c:v>
                  </c:pt>
                  <c:pt idx="1">
                    <c:v>0.00249592</c:v>
                  </c:pt>
                  <c:pt idx="2">
                    <c:v>0.00085916</c:v>
                  </c:pt>
                  <c:pt idx="3">
                    <c:v>0.00166078</c:v>
                  </c:pt>
                  <c:pt idx="4">
                    <c:v>0.00040574</c:v>
                  </c:pt>
                </c:numCache>
              </c:numRef>
            </c:minus>
          </c:errBars>
          <c:cat>
            <c:strRef>
              <c:f>'pretretment liquid_Cal_JMP '!$Q$1:$U$1</c:f>
              <c:strCache>
                <c:ptCount val="5"/>
                <c:pt idx="0">
                  <c:v> Glucan </c:v>
                </c:pt>
                <c:pt idx="1">
                  <c:v>Xylan </c:v>
                </c:pt>
                <c:pt idx="2">
                  <c:v>Mannan</c:v>
                </c:pt>
                <c:pt idx="3">
                  <c:v>Galactan </c:v>
                </c:pt>
                <c:pt idx="4">
                  <c:v>Arabinan</c:v>
                </c:pt>
              </c:strCache>
            </c:strRef>
          </c:cat>
          <c:val>
            <c:numRef>
              <c:f>'pretretment liquid_Cal_JMP '!$Q$24:$U$24</c:f>
              <c:numCache>
                <c:formatCode>General</c:formatCode>
                <c:ptCount val="5"/>
                <c:pt idx="0">
                  <c:v>0.08412956</c:v>
                </c:pt>
                <c:pt idx="1">
                  <c:v>0.16949827</c:v>
                </c:pt>
                <c:pt idx="2">
                  <c:v>0.0236585</c:v>
                </c:pt>
                <c:pt idx="3">
                  <c:v>0.01547486</c:v>
                </c:pt>
                <c:pt idx="4">
                  <c:v>0.0125914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75841744"/>
        <c:axId val="2075830464"/>
      </c:barChart>
      <c:catAx>
        <c:axId val="207584174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075830464"/>
        <c:crosses val="autoZero"/>
        <c:auto val="1"/>
        <c:lblAlgn val="ctr"/>
        <c:lblOffset val="100"/>
        <c:noMultiLvlLbl val="0"/>
      </c:catAx>
      <c:valAx>
        <c:axId val="207583046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Yield of sugars (g g-1)</a:t>
                </a:r>
              </a:p>
            </c:rich>
          </c:tx>
          <c:layout/>
          <c:overlay val="0"/>
        </c:title>
        <c:numFmt formatCode="#,##0.00" sourceLinked="0"/>
        <c:majorTickMark val="out"/>
        <c:minorTickMark val="none"/>
        <c:tickLblPos val="nextTo"/>
        <c:crossAx val="2075841744"/>
        <c:crosses val="autoZero"/>
        <c:crossBetween val="between"/>
        <c:majorUnit val="0.04"/>
      </c:valAx>
    </c:plotArea>
    <c:legend>
      <c:legendPos val="r"/>
      <c:layout/>
      <c:overlay val="0"/>
    </c:legend>
    <c:plotVisOnly val="1"/>
    <c:dispBlanksAs val="gap"/>
    <c:showDLblsOverMax val="0"/>
  </c:chart>
  <c:txPr>
    <a:bodyPr/>
    <a:lstStyle/>
    <a:p>
      <a:pPr>
        <a:defRPr sz="800">
          <a:latin typeface="Helvetica" charset="0"/>
          <a:ea typeface="Helvetica" charset="0"/>
          <a:cs typeface="Helvetica" charset="0"/>
        </a:defRPr>
      </a:pPr>
      <a:endParaRPr lang="en-US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8289</cdr:x>
      <cdr:y>0.5</cdr:y>
    </cdr:from>
    <cdr:to>
      <cdr:x>0.30214</cdr:x>
      <cdr:y>0.5</cdr:y>
    </cdr:to>
    <cdr:cxnSp macro="">
      <cdr:nvCxnSpPr>
        <cdr:cNvPr id="2" name="Straight Connector 1"/>
        <cdr:cNvCxnSpPr/>
      </cdr:nvCxnSpPr>
      <cdr:spPr>
        <a:xfrm xmlns:a="http://schemas.openxmlformats.org/drawingml/2006/main" flipV="1">
          <a:off x="681983" y="989810"/>
          <a:ext cx="444639" cy="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17062</cdr:x>
      <cdr:y>0.36578</cdr:y>
    </cdr:from>
    <cdr:to>
      <cdr:x>0.30844</cdr:x>
      <cdr:y>0.49637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636214" y="724106"/>
          <a:ext cx="513913" cy="258523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sv-SE" sz="800">
              <a:solidFill>
                <a:schemeClr val="tx1">
                  <a:lumMod val="75000"/>
                  <a:lumOff val="25000"/>
                </a:schemeClr>
              </a:solidFill>
              <a:latin typeface="Helvetica" panose="020B0604020202020204" pitchFamily="34" charset="0"/>
              <a:cs typeface="Helvetica" panose="020B0604020202020204" pitchFamily="34" charset="0"/>
            </a:rPr>
            <a:t>+17%</a:t>
          </a:r>
          <a:endParaRPr lang="en-US" sz="800" dirty="0">
            <a:solidFill>
              <a:schemeClr val="tx1">
                <a:lumMod val="75000"/>
                <a:lumOff val="25000"/>
              </a:schemeClr>
            </a:solidFill>
            <a:latin typeface="Helvetica" panose="020B0604020202020204" pitchFamily="34" charset="0"/>
            <a:cs typeface="Helvetica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29008</cdr:x>
      <cdr:y>0.01368</cdr:y>
    </cdr:from>
    <cdr:to>
      <cdr:x>0.70992</cdr:x>
      <cdr:y>0.12251</cdr:y>
    </cdr:to>
    <cdr:sp macro="" textlink="">
      <cdr:nvSpPr>
        <cdr:cNvPr id="6" name="TextBox 5"/>
        <cdr:cNvSpPr txBox="1"/>
      </cdr:nvSpPr>
      <cdr:spPr>
        <a:xfrm xmlns:a="http://schemas.openxmlformats.org/drawingml/2006/main">
          <a:off x="1081657" y="27079"/>
          <a:ext cx="1565528" cy="215444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sv-SE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sv-SE" sz="800" i="1" dirty="0" smtClean="0">
              <a:latin typeface="Helvetica" panose="020B0604020202020204" pitchFamily="34" charset="0"/>
              <a:cs typeface="Helvetica" panose="020B0604020202020204" pitchFamily="34" charset="0"/>
            </a:rPr>
            <a:t>P</a:t>
          </a:r>
          <a:r>
            <a:rPr lang="sv-SE" sz="800" dirty="0" smtClean="0">
              <a:latin typeface="Helvetica" panose="020B0604020202020204" pitchFamily="34" charset="0"/>
              <a:cs typeface="Helvetica" panose="020B0604020202020204" pitchFamily="34" charset="0"/>
            </a:rPr>
            <a:t> ≤ 0.0005 (</a:t>
          </a:r>
          <a:r>
            <a:rPr lang="sv-SE" sz="800" dirty="0" err="1" smtClean="0">
              <a:latin typeface="Helvetica" panose="020B0604020202020204" pitchFamily="34" charset="0"/>
              <a:cs typeface="Helvetica" panose="020B0604020202020204" pitchFamily="34" charset="0"/>
            </a:rPr>
            <a:t>Glc</a:t>
          </a:r>
          <a:r>
            <a:rPr lang="sv-SE" sz="800" dirty="0" smtClean="0">
              <a:latin typeface="Helvetica" panose="020B0604020202020204" pitchFamily="34" charset="0"/>
              <a:cs typeface="Helvetica" panose="020B0604020202020204" pitchFamily="34" charset="0"/>
            </a:rPr>
            <a:t>); </a:t>
          </a:r>
          <a:r>
            <a:rPr lang="sv-SE" sz="800" i="1" dirty="0">
              <a:latin typeface="Helvetica" panose="020B0604020202020204" pitchFamily="34" charset="0"/>
              <a:cs typeface="Helvetica" panose="020B0604020202020204" pitchFamily="34" charset="0"/>
            </a:rPr>
            <a:t>P</a:t>
          </a:r>
          <a:r>
            <a:rPr lang="sv-SE" sz="800" dirty="0">
              <a:latin typeface="Helvetica" panose="020B0604020202020204" pitchFamily="34" charset="0"/>
              <a:cs typeface="Helvetica" panose="020B0604020202020204" pitchFamily="34" charset="0"/>
            </a:rPr>
            <a:t> ≤ </a:t>
          </a:r>
          <a:r>
            <a:rPr lang="sv-SE" sz="800" dirty="0" smtClean="0">
              <a:latin typeface="Helvetica" panose="020B0604020202020204" pitchFamily="34" charset="0"/>
              <a:cs typeface="Helvetica" panose="020B0604020202020204" pitchFamily="34" charset="0"/>
            </a:rPr>
            <a:t>0.1 (Ara) </a:t>
          </a:r>
          <a:endParaRPr lang="en-US" sz="800" dirty="0">
            <a:latin typeface="Helvetica" panose="020B0604020202020204" pitchFamily="34" charset="0"/>
            <a:cs typeface="Helvetica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21159</cdr:x>
      <cdr:y>0.1049</cdr:y>
    </cdr:from>
    <cdr:to>
      <cdr:x>0.78841</cdr:x>
      <cdr:y>0.1049</cdr:y>
    </cdr:to>
    <cdr:cxnSp macro="">
      <cdr:nvCxnSpPr>
        <cdr:cNvPr id="9" name="Straight Connector 8"/>
        <cdr:cNvCxnSpPr/>
      </cdr:nvCxnSpPr>
      <cdr:spPr>
        <a:xfrm xmlns:a="http://schemas.openxmlformats.org/drawingml/2006/main">
          <a:off x="789001" y="207667"/>
          <a:ext cx="2150840" cy="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19292</cdr:x>
      <cdr:y>0.58815</cdr:y>
    </cdr:from>
    <cdr:to>
      <cdr:x>0.25069</cdr:x>
      <cdr:y>0.78704</cdr:y>
    </cdr:to>
    <cdr:sp macro="" textlink="">
      <cdr:nvSpPr>
        <cdr:cNvPr id="10" name="TextBox 9"/>
        <cdr:cNvSpPr txBox="1"/>
      </cdr:nvSpPr>
      <cdr:spPr>
        <a:xfrm xmlns:a="http://schemas.openxmlformats.org/drawingml/2006/main" rot="5400000">
          <a:off x="630211" y="1253459"/>
          <a:ext cx="393732" cy="215444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800" dirty="0" smtClean="0">
              <a:solidFill>
                <a:schemeClr val="tx1"/>
              </a:solidFill>
              <a:latin typeface="Times New Roman"/>
              <a:cs typeface="Times New Roman"/>
            </a:rPr>
            <a:t>**</a:t>
          </a:r>
          <a:endParaRPr lang="en-US" sz="800" dirty="0">
            <a:solidFill>
              <a:schemeClr val="tx1"/>
            </a:solidFill>
          </a:endParaRPr>
        </a:p>
      </cdr:txBody>
    </cdr:sp>
  </cdr:relSizeAnchor>
  <cdr:relSizeAnchor xmlns:cdr="http://schemas.openxmlformats.org/drawingml/2006/chartDrawing">
    <cdr:from>
      <cdr:x>0.23815</cdr:x>
      <cdr:y>0.58703</cdr:y>
    </cdr:from>
    <cdr:to>
      <cdr:x>0.29592</cdr:x>
      <cdr:y>0.78592</cdr:y>
    </cdr:to>
    <cdr:sp macro="" textlink="">
      <cdr:nvSpPr>
        <cdr:cNvPr id="11" name="TextBox 10"/>
        <cdr:cNvSpPr txBox="1"/>
      </cdr:nvSpPr>
      <cdr:spPr>
        <a:xfrm xmlns:a="http://schemas.openxmlformats.org/drawingml/2006/main" rot="5400000">
          <a:off x="798868" y="1251238"/>
          <a:ext cx="393727" cy="215444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800" dirty="0" smtClean="0">
              <a:solidFill>
                <a:schemeClr val="tx1"/>
              </a:solidFill>
              <a:latin typeface="Times New Roman"/>
              <a:cs typeface="Times New Roman"/>
            </a:rPr>
            <a:t>**</a:t>
          </a:r>
          <a:endParaRPr lang="en-US" sz="800" dirty="0">
            <a:solidFill>
              <a:schemeClr val="tx1"/>
            </a:solidFill>
          </a:endParaRPr>
        </a:p>
      </cdr:txBody>
    </cdr:sp>
  </cdr:relSizeAnchor>
  <cdr:relSizeAnchor xmlns:cdr="http://schemas.openxmlformats.org/drawingml/2006/chartDrawing">
    <cdr:from>
      <cdr:x>0.37261</cdr:x>
      <cdr:y>0.22984</cdr:y>
    </cdr:from>
    <cdr:to>
      <cdr:x>0.43039</cdr:x>
      <cdr:y>0.40304</cdr:y>
    </cdr:to>
    <cdr:sp macro="" textlink="">
      <cdr:nvSpPr>
        <cdr:cNvPr id="12" name="TextBox 11"/>
        <cdr:cNvSpPr txBox="1"/>
      </cdr:nvSpPr>
      <cdr:spPr>
        <a:xfrm xmlns:a="http://schemas.openxmlformats.org/drawingml/2006/main" rot="5400000">
          <a:off x="1325703" y="518716"/>
          <a:ext cx="342875" cy="215444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800" dirty="0" smtClean="0">
              <a:solidFill>
                <a:schemeClr val="tx1"/>
              </a:solidFill>
              <a:latin typeface="Times New Roman"/>
              <a:cs typeface="Times New Roman"/>
            </a:rPr>
            <a:t>**</a:t>
          </a:r>
          <a:endParaRPr lang="en-US" sz="800" dirty="0">
            <a:solidFill>
              <a:schemeClr val="tx1"/>
            </a:solidFill>
          </a:endParaRPr>
        </a:p>
      </cdr:txBody>
    </cdr:sp>
  </cdr:relSizeAnchor>
  <cdr:relSizeAnchor xmlns:cdr="http://schemas.openxmlformats.org/drawingml/2006/chartDrawing">
    <cdr:from>
      <cdr:x>0.45165</cdr:x>
      <cdr:y>0.73886</cdr:y>
    </cdr:from>
    <cdr:to>
      <cdr:x>0.50943</cdr:x>
      <cdr:y>0.93775</cdr:y>
    </cdr:to>
    <cdr:sp macro="" textlink="">
      <cdr:nvSpPr>
        <cdr:cNvPr id="13" name="TextBox 12"/>
        <cdr:cNvSpPr txBox="1"/>
      </cdr:nvSpPr>
      <cdr:spPr>
        <a:xfrm xmlns:a="http://schemas.openxmlformats.org/drawingml/2006/main" rot="5400000">
          <a:off x="1594998" y="1551805"/>
          <a:ext cx="393727" cy="21545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800" dirty="0" smtClean="0">
              <a:solidFill>
                <a:schemeClr val="tx1"/>
              </a:solidFill>
              <a:latin typeface="Times New Roman"/>
              <a:cs typeface="Times New Roman"/>
            </a:rPr>
            <a:t>**</a:t>
          </a:r>
          <a:endParaRPr lang="en-US" sz="800" dirty="0">
            <a:solidFill>
              <a:schemeClr val="tx1"/>
            </a:solidFill>
          </a:endParaRPr>
        </a:p>
      </cdr:txBody>
    </cdr:sp>
  </cdr:relSizeAnchor>
  <cdr:relSizeAnchor xmlns:cdr="http://schemas.openxmlformats.org/drawingml/2006/chartDrawing">
    <cdr:from>
      <cdr:x>0.71285</cdr:x>
      <cdr:y>0.68446</cdr:y>
    </cdr:from>
    <cdr:to>
      <cdr:x>0.77063</cdr:x>
      <cdr:y>0.88336</cdr:y>
    </cdr:to>
    <cdr:sp macro="" textlink="">
      <cdr:nvSpPr>
        <cdr:cNvPr id="14" name="TextBox 13"/>
        <cdr:cNvSpPr txBox="1"/>
      </cdr:nvSpPr>
      <cdr:spPr>
        <a:xfrm xmlns:a="http://schemas.openxmlformats.org/drawingml/2006/main" rot="5400000">
          <a:off x="2568962" y="1444124"/>
          <a:ext cx="393732" cy="215444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800" dirty="0" smtClean="0">
              <a:solidFill>
                <a:schemeClr val="tx1"/>
              </a:solidFill>
              <a:latin typeface="Times New Roman"/>
              <a:cs typeface="Times New Roman"/>
            </a:rPr>
            <a:t>**</a:t>
          </a:r>
          <a:endParaRPr lang="en-US" sz="800" dirty="0">
            <a:solidFill>
              <a:schemeClr val="tx1"/>
            </a:solidFill>
          </a:endParaRPr>
        </a:p>
      </cdr:txBody>
    </cdr:sp>
  </cdr:relSizeAnchor>
  <cdr:relSizeAnchor xmlns:cdr="http://schemas.openxmlformats.org/drawingml/2006/chartDrawing">
    <cdr:from>
      <cdr:x>0.7378</cdr:x>
      <cdr:y>0.685</cdr:y>
    </cdr:from>
    <cdr:to>
      <cdr:x>0.79558</cdr:x>
      <cdr:y>0.88389</cdr:y>
    </cdr:to>
    <cdr:sp macro="" textlink="">
      <cdr:nvSpPr>
        <cdr:cNvPr id="15" name="TextBox 14"/>
        <cdr:cNvSpPr txBox="1"/>
      </cdr:nvSpPr>
      <cdr:spPr>
        <a:xfrm xmlns:a="http://schemas.openxmlformats.org/drawingml/2006/main" rot="5400000">
          <a:off x="2661992" y="1445183"/>
          <a:ext cx="393727" cy="21545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800" dirty="0" smtClean="0">
              <a:solidFill>
                <a:schemeClr val="tx1"/>
              </a:solidFill>
              <a:latin typeface="Times New Roman"/>
              <a:cs typeface="Times New Roman"/>
            </a:rPr>
            <a:t>**</a:t>
          </a:r>
          <a:endParaRPr lang="en-US" sz="800" dirty="0">
            <a:solidFill>
              <a:schemeClr val="tx1"/>
            </a:solidFill>
          </a:endParaRPr>
        </a:p>
      </cdr:txBody>
    </cdr:sp>
  </cdr:relSizeAnchor>
  <cdr:relSizeAnchor xmlns:cdr="http://schemas.openxmlformats.org/drawingml/2006/chartDrawing">
    <cdr:from>
      <cdr:x>0.76278</cdr:x>
      <cdr:y>0.68468</cdr:y>
    </cdr:from>
    <cdr:to>
      <cdr:x>0.82056</cdr:x>
      <cdr:y>0.83202</cdr:y>
    </cdr:to>
    <cdr:sp macro="" textlink="">
      <cdr:nvSpPr>
        <cdr:cNvPr id="16" name="TextBox 15"/>
        <cdr:cNvSpPr txBox="1"/>
      </cdr:nvSpPr>
      <cdr:spPr>
        <a:xfrm xmlns:a="http://schemas.openxmlformats.org/drawingml/2006/main" rot="5400000">
          <a:off x="2806172" y="1393524"/>
          <a:ext cx="291670" cy="215453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800" dirty="0" smtClean="0">
              <a:solidFill>
                <a:schemeClr val="tx1"/>
              </a:solidFill>
              <a:latin typeface="Times New Roman"/>
              <a:cs typeface="Times New Roman"/>
            </a:rPr>
            <a:t>**</a:t>
          </a:r>
          <a:endParaRPr lang="en-US" sz="800" dirty="0">
            <a:solidFill>
              <a:schemeClr val="tx1"/>
            </a:solidFill>
          </a:endParaRPr>
        </a:p>
      </cdr:txBody>
    </cdr:sp>
  </cdr:relSizeAnchor>
</c:userShape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3" y="0"/>
            <a:ext cx="2946189" cy="496411"/>
          </a:xfrm>
          <a:prstGeom prst="rect">
            <a:avLst/>
          </a:prstGeom>
        </p:spPr>
        <p:txBody>
          <a:bodyPr vert="horz" lIns="91557" tIns="45781" rIns="91557" bIns="45781" rtlCol="0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49901" y="0"/>
            <a:ext cx="2946189" cy="496411"/>
          </a:xfrm>
          <a:prstGeom prst="rect">
            <a:avLst/>
          </a:prstGeom>
        </p:spPr>
        <p:txBody>
          <a:bodyPr vert="horz" lIns="91557" tIns="45781" rIns="91557" bIns="45781" rtlCol="0"/>
          <a:lstStyle>
            <a:lvl1pPr algn="r">
              <a:defRPr sz="1200"/>
            </a:lvl1pPr>
          </a:lstStyle>
          <a:p>
            <a:fld id="{2FF1960E-E555-4FA3-9B89-F6C507E6E2AA}" type="datetimeFigureOut">
              <a:rPr lang="sv-SE" smtClean="0"/>
              <a:t>2017-01-12</a:t>
            </a:fld>
            <a:endParaRPr lang="sv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3" y="9430223"/>
            <a:ext cx="2946189" cy="496411"/>
          </a:xfrm>
          <a:prstGeom prst="rect">
            <a:avLst/>
          </a:prstGeom>
        </p:spPr>
        <p:txBody>
          <a:bodyPr vert="horz" lIns="91557" tIns="45781" rIns="91557" bIns="45781" rtlCol="0" anchor="b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49901" y="9430223"/>
            <a:ext cx="2946189" cy="496411"/>
          </a:xfrm>
          <a:prstGeom prst="rect">
            <a:avLst/>
          </a:prstGeom>
        </p:spPr>
        <p:txBody>
          <a:bodyPr vert="horz" lIns="91557" tIns="45781" rIns="91557" bIns="45781" rtlCol="0" anchor="b"/>
          <a:lstStyle>
            <a:lvl1pPr algn="r">
              <a:defRPr sz="1200"/>
            </a:lvl1pPr>
          </a:lstStyle>
          <a:p>
            <a:fld id="{7C1B93AD-520F-4581-BE6F-51B87980073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5209924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6189" cy="496411"/>
          </a:xfrm>
          <a:prstGeom prst="rect">
            <a:avLst/>
          </a:prstGeom>
        </p:spPr>
        <p:txBody>
          <a:bodyPr vert="horz" lIns="91577" tIns="45789" rIns="91577" bIns="45789" rtlCol="0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899" y="0"/>
            <a:ext cx="2946189" cy="496411"/>
          </a:xfrm>
          <a:prstGeom prst="rect">
            <a:avLst/>
          </a:prstGeom>
        </p:spPr>
        <p:txBody>
          <a:bodyPr vert="horz" lIns="91577" tIns="45789" rIns="91577" bIns="45789" rtlCol="0"/>
          <a:lstStyle>
            <a:lvl1pPr algn="r">
              <a:defRPr sz="1200"/>
            </a:lvl1pPr>
          </a:lstStyle>
          <a:p>
            <a:fld id="{E4AFCDE8-A4CE-4EFF-90A2-ECD6F20BC010}" type="datetimeFigureOut">
              <a:rPr lang="sv-SE" smtClean="0"/>
              <a:t>2017-01-12</a:t>
            </a:fld>
            <a:endParaRPr lang="sv-S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933575" y="744538"/>
            <a:ext cx="2930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577" tIns="45789" rIns="91577" bIns="45789" rtlCol="0" anchor="ctr"/>
          <a:lstStyle/>
          <a:p>
            <a:endParaRPr lang="sv-S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577" tIns="45789" rIns="91577" bIns="4578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9430223"/>
            <a:ext cx="2946189" cy="496411"/>
          </a:xfrm>
          <a:prstGeom prst="rect">
            <a:avLst/>
          </a:prstGeom>
        </p:spPr>
        <p:txBody>
          <a:bodyPr vert="horz" lIns="91577" tIns="45789" rIns="91577" bIns="45789" rtlCol="0" anchor="b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899" y="9430223"/>
            <a:ext cx="2946189" cy="496411"/>
          </a:xfrm>
          <a:prstGeom prst="rect">
            <a:avLst/>
          </a:prstGeom>
        </p:spPr>
        <p:txBody>
          <a:bodyPr vert="horz" lIns="91577" tIns="45789" rIns="91577" bIns="45789" rtlCol="0" anchor="b"/>
          <a:lstStyle>
            <a:lvl1pPr algn="r">
              <a:defRPr sz="1200"/>
            </a:lvl1pPr>
          </a:lstStyle>
          <a:p>
            <a:fld id="{745306A8-4DFD-4413-A84A-BFC106AD664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162331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0069" y="2840569"/>
            <a:ext cx="6120765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80135" y="5181600"/>
            <a:ext cx="504063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036F4-A069-4F11-BE7E-7A3C4C4E2882}" type="datetime1">
              <a:rPr lang="sv-SE" smtClean="0"/>
              <a:t>2017-01-12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9E9F1-820E-4EB4-BD74-329B6C2459E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899130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A7EC7-A8ED-4E57-AD02-F8627BD99325}" type="datetime1">
              <a:rPr lang="sv-SE" smtClean="0"/>
              <a:t>2017-01-12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9E9F1-820E-4EB4-BD74-329B6C2459E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0186307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20652" y="366187"/>
            <a:ext cx="1620203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60046" y="366187"/>
            <a:ext cx="4740593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765F9-6B29-4AF2-A37B-05089206B78B}" type="datetime1">
              <a:rPr lang="sv-SE" smtClean="0"/>
              <a:t>2017-01-12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9E9F1-820E-4EB4-BD74-329B6C2459E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894204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C4E50-9D58-40CD-86C2-165D68EDC912}" type="datetime1">
              <a:rPr lang="sv-SE" smtClean="0"/>
              <a:t>2017-01-12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9E9F1-820E-4EB4-BD74-329B6C2459E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6745187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8823" y="5875867"/>
            <a:ext cx="6120765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8823" y="3875621"/>
            <a:ext cx="6120765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CDA7F7-A8EC-4B47-93E2-EA186C502563}" type="datetime1">
              <a:rPr lang="sv-SE" smtClean="0"/>
              <a:t>2017-01-12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9E9F1-820E-4EB4-BD74-329B6C2459E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550441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60045" y="2133604"/>
            <a:ext cx="3180398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60457" y="2133604"/>
            <a:ext cx="3180398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2059E-B7C7-4ADE-BAE4-D3E07BAA057E}" type="datetime1">
              <a:rPr lang="sv-SE" smtClean="0"/>
              <a:t>2017-01-12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9E9F1-820E-4EB4-BD74-329B6C2459E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1377667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0047" y="2046817"/>
            <a:ext cx="3181648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0047" y="2899833"/>
            <a:ext cx="3181648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57959" y="2046817"/>
            <a:ext cx="3182898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57959" y="2899833"/>
            <a:ext cx="3182898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AD9705-B01C-46C3-BA33-48D1DA937F7E}" type="datetime1">
              <a:rPr lang="sv-SE" smtClean="0"/>
              <a:t>2017-01-12</a:t>
            </a:fld>
            <a:endParaRPr lang="sv-S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9E9F1-820E-4EB4-BD74-329B6C2459E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1196550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E56B54-9DF1-4CA6-9C22-F861898EF72C}" type="datetime1">
              <a:rPr lang="sv-SE" smtClean="0"/>
              <a:t>2017-01-12</a:t>
            </a:fld>
            <a:endParaRPr lang="sv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9E9F1-820E-4EB4-BD74-329B6C2459E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5905269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1439F4-3F18-4A1A-B292-BB63CADEFD07}" type="datetime1">
              <a:rPr lang="sv-SE" smtClean="0"/>
              <a:t>2017-01-12</a:t>
            </a:fld>
            <a:endParaRPr lang="sv-S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9E9F1-820E-4EB4-BD74-329B6C2459E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2379479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0046" y="364067"/>
            <a:ext cx="2369047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815353" y="364070"/>
            <a:ext cx="4025504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60046" y="1913470"/>
            <a:ext cx="2369047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986FE4-47C4-4A27-B682-7CC63600B5A7}" type="datetime1">
              <a:rPr lang="sv-SE" smtClean="0"/>
              <a:t>2017-01-12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9E9F1-820E-4EB4-BD74-329B6C2459E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214915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11427" y="6400803"/>
            <a:ext cx="432054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411427" y="817033"/>
            <a:ext cx="432054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11427" y="7156454"/>
            <a:ext cx="432054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5B887-CE02-4C8D-95DA-1259335DE4B0}" type="datetime1">
              <a:rPr lang="sv-SE" smtClean="0"/>
              <a:t>2017-01-12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9E9F1-820E-4EB4-BD74-329B6C2459E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90564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60045" y="366184"/>
            <a:ext cx="648081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0045" y="2133604"/>
            <a:ext cx="648081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60045" y="8475137"/>
            <a:ext cx="168021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7B854E-4C3B-470B-AFE8-A93947DE2736}" type="datetime1">
              <a:rPr lang="sv-SE" smtClean="0"/>
              <a:t>2017-01-12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60309" y="8475137"/>
            <a:ext cx="228028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0645" y="8475137"/>
            <a:ext cx="168021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C9E9F1-820E-4EB4-BD74-329B6C2459E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5475218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/>
          <p:cNvSpPr txBox="1"/>
          <p:nvPr/>
        </p:nvSpPr>
        <p:spPr>
          <a:xfrm>
            <a:off x="1273660" y="4785409"/>
            <a:ext cx="4583257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just"/>
            <a:r>
              <a:rPr lang="en-US" sz="10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Additional file </a:t>
            </a:r>
            <a:r>
              <a:rPr lang="en-US" sz="10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3.</a:t>
            </a:r>
            <a:r>
              <a:rPr lang="en-US" sz="1000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0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Yield of sugars in </a:t>
            </a:r>
            <a:r>
              <a:rPr lang="en-US" sz="1000" b="1" dirty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pretreatment </a:t>
            </a:r>
            <a:r>
              <a:rPr lang="en-US" sz="10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liquid of transgenic and WT samples.</a:t>
            </a:r>
            <a:r>
              <a:rPr lang="en-US" sz="1000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sv-SE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Means</a:t>
            </a:r>
            <a:r>
              <a:rPr lang="sv-SE" sz="1000" dirty="0">
                <a:latin typeface="Helvetica" panose="020B0604020202020204" pitchFamily="34" charset="0"/>
                <a:cs typeface="Helvetica" panose="020B0604020202020204" pitchFamily="34" charset="0"/>
              </a:rPr>
              <a:t> ± </a:t>
            </a:r>
            <a:r>
              <a:rPr lang="sv-SE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SE</a:t>
            </a:r>
            <a:r>
              <a:rPr lang="sv-SE" sz="1000" dirty="0">
                <a:latin typeface="Helvetica" panose="020B0604020202020204" pitchFamily="34" charset="0"/>
                <a:cs typeface="Helvetica" panose="020B0604020202020204" pitchFamily="34" charset="0"/>
              </a:rPr>
              <a:t>, </a:t>
            </a:r>
            <a:r>
              <a:rPr lang="sv-SE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n</a:t>
            </a:r>
            <a:r>
              <a:rPr lang="sv-SE" sz="1000" dirty="0">
                <a:latin typeface="Helvetica" panose="020B0604020202020204" pitchFamily="34" charset="0"/>
                <a:cs typeface="Helvetica" panose="020B0604020202020204" pitchFamily="34" charset="0"/>
              </a:rPr>
              <a:t> = 5 </a:t>
            </a:r>
            <a:r>
              <a:rPr lang="sv-SE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biological</a:t>
            </a:r>
            <a:r>
              <a:rPr lang="sv-SE" sz="10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sv-SE" sz="1000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replicates</a:t>
            </a:r>
            <a:r>
              <a:rPr lang="sv-SE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 </a:t>
            </a:r>
            <a:r>
              <a:rPr lang="en-US" sz="1000" dirty="0" smtClean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Asterisks mark </a:t>
            </a:r>
            <a:r>
              <a:rPr lang="en-US" sz="1000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lines significantly different from WT: </a:t>
            </a:r>
            <a:r>
              <a:rPr lang="en-US" sz="1000" dirty="0" smtClean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** </a:t>
            </a:r>
            <a:r>
              <a:rPr lang="en-US" sz="1000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- </a:t>
            </a:r>
            <a:r>
              <a:rPr lang="en-US" sz="1000" i="1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P </a:t>
            </a:r>
            <a:r>
              <a:rPr lang="en-US" sz="1000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≤ </a:t>
            </a:r>
            <a:r>
              <a:rPr lang="en-US" sz="1000" dirty="0" smtClean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0.05</a:t>
            </a:r>
            <a:r>
              <a:rPr lang="en-US" sz="1000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000" dirty="0" smtClean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(Student’s </a:t>
            </a:r>
            <a:r>
              <a:rPr lang="en-US" sz="1000" i="1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t</a:t>
            </a:r>
            <a:r>
              <a:rPr lang="en-US" sz="1000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-test). </a:t>
            </a:r>
            <a:r>
              <a:rPr lang="en-US" sz="1000" i="1" dirty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P</a:t>
            </a:r>
            <a:r>
              <a:rPr lang="en-US" sz="1000" dirty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 value corresponds to post-ANOVA contrast analysis comparing all transgenic lines to WT. </a:t>
            </a:r>
          </a:p>
        </p:txBody>
      </p:sp>
      <p:graphicFrame>
        <p:nvGraphicFramePr>
          <p:cNvPr id="24" name="Chart 2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76452148"/>
              </p:ext>
            </p:extLst>
          </p:nvPr>
        </p:nvGraphicFramePr>
        <p:xfrm>
          <a:off x="1316213" y="2555875"/>
          <a:ext cx="3728842" cy="19796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4545373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8431</TotalTime>
  <Words>86</Words>
  <Application>Microsoft Macintosh PowerPoint</Application>
  <PresentationFormat>Custom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Calibri</vt:lpstr>
      <vt:lpstr>Helvetica</vt:lpstr>
      <vt:lpstr>Times New Roman</vt:lpstr>
      <vt:lpstr>Arial</vt:lpstr>
      <vt:lpstr>Office Theme</vt:lpstr>
      <vt:lpstr>PowerPoint Presentation</vt:lpstr>
    </vt:vector>
  </TitlesOfParts>
  <Company>HP</Company>
  <LinksUpToDate>false</LinksUpToDate>
  <SharedDoc>false</SharedDoc>
  <HyperlinksChanged>false</HyperlinksChanged>
  <AppVersion>15.0029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ine Ratke</dc:creator>
  <cp:lastModifiedBy>Microsoft Office User</cp:lastModifiedBy>
  <cp:revision>982</cp:revision>
  <cp:lastPrinted>2014-10-29T14:52:00Z</cp:lastPrinted>
  <dcterms:created xsi:type="dcterms:W3CDTF">2012-08-30T12:05:59Z</dcterms:created>
  <dcterms:modified xsi:type="dcterms:W3CDTF">2017-01-12T12:49:09Z</dcterms:modified>
</cp:coreProperties>
</file>